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997"/>
    <p:restoredTop sz="95946"/>
  </p:normalViewPr>
  <p:slideViewPr>
    <p:cSldViewPr snapToGrid="0" snapToObjects="1">
      <p:cViewPr>
        <p:scale>
          <a:sx n="93" d="100"/>
          <a:sy n="93" d="100"/>
        </p:scale>
        <p:origin x="1552" y="6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7/1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68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7/1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213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7/1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063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7/1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322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7/1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390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7/1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360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7/19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773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7/19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128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7/19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988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7/1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786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7/1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381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CD0879-DB1B-014C-86CD-92415D941DD4}" type="datetimeFigureOut">
              <a:rPr lang="en-US" smtClean="0"/>
              <a:t>7/1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784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3843FA6-A6E6-7049-AC71-CA2061E0CD3A}"/>
              </a:ext>
            </a:extLst>
          </p:cNvPr>
          <p:cNvSpPr txBox="1"/>
          <p:nvPr/>
        </p:nvSpPr>
        <p:spPr>
          <a:xfrm>
            <a:off x="0" y="5921608"/>
            <a:ext cx="9144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Description of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DNA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methylation using the HM450 microarray.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16 high confidence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DNA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annotated in the GRCh37/hg19 human genome (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top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. 138 of them are included in the HM450 DNA methylation microarray. 95 of these 138 are located further than 2 kb from any other RNAPII-transcribed gene. The withdrawal of cross-reactive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yielded the 71 different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DNA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hat can be efficiently interrogated with this approach (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below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. The distribution by amino acid and anticodon of the 416 total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DNA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genes (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top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 and those of the 71 that are represented in the HM450 DNA methylation microarray (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below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 are provided. (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 Average methylation of the 71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DNA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genes according to the HM450 DNA methylation microarray data in normal (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middle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 TCGA samples and in cell lines (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. FDR-adjusted 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values correspond to the Mann-Whitney U-test used to compare the methylation average between TCGA normal and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samples. ns, not significant; * FDR &lt; 0.05; ** FDR &lt; 0.01; *** FDR &lt; 0.001.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E79ED408-F1D5-0549-AB35-E1F510001E20}"/>
              </a:ext>
            </a:extLst>
          </p:cNvPr>
          <p:cNvGrpSpPr>
            <a:grpSpLocks noChangeAspect="1"/>
          </p:cNvGrpSpPr>
          <p:nvPr/>
        </p:nvGrpSpPr>
        <p:grpSpPr>
          <a:xfrm>
            <a:off x="574768" y="178416"/>
            <a:ext cx="4491172" cy="5445099"/>
            <a:chOff x="182209" y="-3107"/>
            <a:chExt cx="4474543" cy="5424937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C7F61BD-BF70-BC42-9EC5-25870132FF42}"/>
                </a:ext>
              </a:extLst>
            </p:cNvPr>
            <p:cNvSpPr txBox="1"/>
            <p:nvPr/>
          </p:nvSpPr>
          <p:spPr>
            <a:xfrm>
              <a:off x="182209" y="3306579"/>
              <a:ext cx="44745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1 high confidence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tDNA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in the HM450 DNA microarray that we can interrogate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50AE9716-F0C7-224F-A233-F2ABC5F5A6F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2209" y="115599"/>
              <a:ext cx="4160538" cy="2050795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D81CAD1-C08E-004C-8167-71EF7240548F}"/>
                </a:ext>
              </a:extLst>
            </p:cNvPr>
            <p:cNvSpPr txBox="1"/>
            <p:nvPr/>
          </p:nvSpPr>
          <p:spPr>
            <a:xfrm>
              <a:off x="182209" y="-3107"/>
              <a:ext cx="28793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16 high confidence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tDNA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genes in human genome (hg19)</a:t>
              </a: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856D73AB-A38E-C443-AE88-7CEC3F52138D}"/>
                </a:ext>
              </a:extLst>
            </p:cNvPr>
            <p:cNvGrpSpPr/>
            <p:nvPr/>
          </p:nvGrpSpPr>
          <p:grpSpPr>
            <a:xfrm>
              <a:off x="836552" y="2040532"/>
              <a:ext cx="3440574" cy="1255803"/>
              <a:chOff x="836552" y="2221678"/>
              <a:chExt cx="3440574" cy="1255803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435648A8-2130-D649-B0E9-765B6C8F093E}"/>
                  </a:ext>
                </a:extLst>
              </p:cNvPr>
              <p:cNvGrpSpPr/>
              <p:nvPr/>
            </p:nvGrpSpPr>
            <p:grpSpPr>
              <a:xfrm>
                <a:off x="836552" y="2221678"/>
                <a:ext cx="3440574" cy="1255803"/>
                <a:chOff x="5703425" y="2076337"/>
                <a:chExt cx="3440574" cy="1255803"/>
              </a:xfrm>
            </p:grpSpPr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09ECB7F9-0776-C94B-ADB9-B76893DC37CA}"/>
                    </a:ext>
                  </a:extLst>
                </p:cNvPr>
                <p:cNvSpPr txBox="1"/>
                <p:nvPr/>
              </p:nvSpPr>
              <p:spPr>
                <a:xfrm>
                  <a:off x="5703425" y="2764140"/>
                  <a:ext cx="3115373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5 </a:t>
                  </a:r>
                  <a:r>
                    <a:rPr lang="en-US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DNA</a:t>
                  </a:r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with CpG inside that are further than 2kb away from other RNAPII genes</a:t>
                  </a:r>
                </a:p>
              </p:txBody>
            </p:sp>
            <p:cxnSp>
              <p:nvCxnSpPr>
                <p:cNvPr id="14" name="Straight Arrow Connector 13">
                  <a:extLst>
                    <a:ext uri="{FF2B5EF4-FFF2-40B4-BE49-F238E27FC236}">
                      <a16:creationId xmlns:a16="http://schemas.microsoft.com/office/drawing/2014/main" id="{5C83FE31-600A-6241-AA04-E8B1D29EC54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261111" y="3116140"/>
                  <a:ext cx="0" cy="216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CD9F86C0-8E34-C14A-BE4A-E16D302C06C4}"/>
                    </a:ext>
                  </a:extLst>
                </p:cNvPr>
                <p:cNvSpPr txBox="1"/>
                <p:nvPr/>
              </p:nvSpPr>
              <p:spPr>
                <a:xfrm>
                  <a:off x="7261111" y="3078076"/>
                  <a:ext cx="188288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iscard cross-reactive CpG</a:t>
                  </a:r>
                </a:p>
              </p:txBody>
            </p:sp>
            <p:cxnSp>
              <p:nvCxnSpPr>
                <p:cNvPr id="16" name="Straight Arrow Connector 15">
                  <a:extLst>
                    <a:ext uri="{FF2B5EF4-FFF2-40B4-BE49-F238E27FC236}">
                      <a16:creationId xmlns:a16="http://schemas.microsoft.com/office/drawing/2014/main" id="{80363ACB-5E5B-424F-8C38-16EB415DB85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261111" y="2076337"/>
                  <a:ext cx="0" cy="216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14E3BB0A-2625-C24E-AAC2-CBFF4DFB283D}"/>
                  </a:ext>
                </a:extLst>
              </p:cNvPr>
              <p:cNvSpPr txBox="1"/>
              <p:nvPr/>
            </p:nvSpPr>
            <p:spPr>
              <a:xfrm>
                <a:off x="836552" y="2451134"/>
                <a:ext cx="311537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38 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DNA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with CpG inside</a:t>
                </a:r>
              </a:p>
            </p:txBody>
          </p:sp>
          <p:cxnSp>
            <p:nvCxnSpPr>
              <p:cNvPr id="12" name="Straight Arrow Connector 11">
                <a:extLst>
                  <a:ext uri="{FF2B5EF4-FFF2-40B4-BE49-F238E27FC236}">
                    <a16:creationId xmlns:a16="http://schemas.microsoft.com/office/drawing/2014/main" id="{93C28A2A-994C-CD4D-85C7-DD164C3C39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94238" y="2680022"/>
                <a:ext cx="0" cy="216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D0B17116-F241-7D4C-8B75-BDAD3A1B384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2209" y="3384989"/>
              <a:ext cx="4160538" cy="2036841"/>
            </a:xfrm>
            <a:prstGeom prst="rect">
              <a:avLst/>
            </a:prstGeom>
          </p:spPr>
        </p:pic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C06ECECE-756C-8E4D-BE07-8E8206C78E94}"/>
              </a:ext>
            </a:extLst>
          </p:cNvPr>
          <p:cNvSpPr txBox="1"/>
          <p:nvPr/>
        </p:nvSpPr>
        <p:spPr>
          <a:xfrm>
            <a:off x="7168152" y="-38461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4913818-420D-E443-A016-F533497EBBC4}"/>
              </a:ext>
            </a:extLst>
          </p:cNvPr>
          <p:cNvSpPr txBox="1"/>
          <p:nvPr/>
        </p:nvSpPr>
        <p:spPr>
          <a:xfrm>
            <a:off x="184100" y="14120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ED8EBAD-4B01-6A4B-80E9-8E6DC20C0FFB}"/>
              </a:ext>
            </a:extLst>
          </p:cNvPr>
          <p:cNvSpPr txBox="1"/>
          <p:nvPr/>
        </p:nvSpPr>
        <p:spPr>
          <a:xfrm>
            <a:off x="4712606" y="14120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8A95D66-5BA2-B54A-A5F4-D4B63B1617CB}"/>
              </a:ext>
            </a:extLst>
          </p:cNvPr>
          <p:cNvPicPr>
            <a:picLocks noChangeAspect="1"/>
          </p:cNvPicPr>
          <p:nvPr/>
        </p:nvPicPr>
        <p:blipFill>
          <a:blip r:embed="rId4">
            <a:lum bright="5000"/>
          </a:blip>
          <a:stretch>
            <a:fillRect/>
          </a:stretch>
        </p:blipFill>
        <p:spPr>
          <a:xfrm>
            <a:off x="4947295" y="238538"/>
            <a:ext cx="3561781" cy="57073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6414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2</TotalTime>
  <Words>245</Words>
  <Application>Microsoft Macintosh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GALIDA ROSSELLO TORTELLA</dc:creator>
  <cp:lastModifiedBy>MARGALIDA ROSSELLO TORTELLA</cp:lastModifiedBy>
  <cp:revision>7</cp:revision>
  <dcterms:created xsi:type="dcterms:W3CDTF">2021-07-05T11:21:51Z</dcterms:created>
  <dcterms:modified xsi:type="dcterms:W3CDTF">2021-07-19T09:39:41Z</dcterms:modified>
</cp:coreProperties>
</file>